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8" r:id="rId3"/>
  </p:sldIdLst>
  <p:sldSz cx="13320713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22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9054" y="1472842"/>
            <a:ext cx="11322606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65089" y="4726842"/>
            <a:ext cx="9990535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463A7-2D1A-4393-8F69-00E828BC2832}" type="datetimeFigureOut">
              <a:rPr lang="zh-CN" altLang="en-US" smtClean="0"/>
              <a:t>2024/9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84DBB-0DFA-4D56-AEBC-3BBE10FB02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2747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463A7-2D1A-4393-8F69-00E828BC2832}" type="datetimeFigureOut">
              <a:rPr lang="zh-CN" altLang="en-US" smtClean="0"/>
              <a:t>2024/9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84DBB-0DFA-4D56-AEBC-3BBE10FB02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1037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32636" y="479142"/>
            <a:ext cx="2872279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5800" y="479142"/>
            <a:ext cx="8450327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463A7-2D1A-4393-8F69-00E828BC2832}" type="datetimeFigureOut">
              <a:rPr lang="zh-CN" altLang="en-US" smtClean="0"/>
              <a:t>2024/9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84DBB-0DFA-4D56-AEBC-3BBE10FB02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2064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463A7-2D1A-4393-8F69-00E828BC2832}" type="datetimeFigureOut">
              <a:rPr lang="zh-CN" altLang="en-US" smtClean="0"/>
              <a:t>2024/9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84DBB-0DFA-4D56-AEBC-3BBE10FB02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0478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8862" y="2243638"/>
            <a:ext cx="11489115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862" y="6022610"/>
            <a:ext cx="11489115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>
                    <a:tint val="82000"/>
                  </a:schemeClr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82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82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463A7-2D1A-4393-8F69-00E828BC2832}" type="datetimeFigureOut">
              <a:rPr lang="zh-CN" altLang="en-US" smtClean="0"/>
              <a:t>2024/9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84DBB-0DFA-4D56-AEBC-3BBE10FB02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64109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5799" y="2395710"/>
            <a:ext cx="5661303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43611" y="2395710"/>
            <a:ext cx="5661303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463A7-2D1A-4393-8F69-00E828BC2832}" type="datetimeFigureOut">
              <a:rPr lang="zh-CN" altLang="en-US" smtClean="0"/>
              <a:t>2024/9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84DBB-0DFA-4D56-AEBC-3BBE10FB02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8833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479144"/>
            <a:ext cx="11489115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7536" y="2206137"/>
            <a:ext cx="5635285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7536" y="3287331"/>
            <a:ext cx="5635285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43612" y="2206137"/>
            <a:ext cx="5663038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43612" y="3287331"/>
            <a:ext cx="5663038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463A7-2D1A-4393-8F69-00E828BC2832}" type="datetimeFigureOut">
              <a:rPr lang="zh-CN" altLang="en-US" smtClean="0"/>
              <a:t>2024/9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84DBB-0DFA-4D56-AEBC-3BBE10FB02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5659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463A7-2D1A-4393-8F69-00E828BC2832}" type="datetimeFigureOut">
              <a:rPr lang="zh-CN" altLang="en-US" smtClean="0"/>
              <a:t>2024/9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84DBB-0DFA-4D56-AEBC-3BBE10FB02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2164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463A7-2D1A-4393-8F69-00E828BC2832}" type="datetimeFigureOut">
              <a:rPr lang="zh-CN" altLang="en-US" smtClean="0"/>
              <a:t>2024/9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84DBB-0DFA-4D56-AEBC-3BBE10FB02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0767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599969"/>
            <a:ext cx="429627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63038" y="1295769"/>
            <a:ext cx="6743611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4" y="2699862"/>
            <a:ext cx="429627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463A7-2D1A-4393-8F69-00E828BC2832}" type="datetimeFigureOut">
              <a:rPr lang="zh-CN" altLang="en-US" smtClean="0"/>
              <a:t>2024/9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84DBB-0DFA-4D56-AEBC-3BBE10FB02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03076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599969"/>
            <a:ext cx="429627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63038" y="1295769"/>
            <a:ext cx="6743611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4" y="2699862"/>
            <a:ext cx="429627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463A7-2D1A-4393-8F69-00E828BC2832}" type="datetimeFigureOut">
              <a:rPr lang="zh-CN" altLang="en-US" smtClean="0"/>
              <a:t>2024/9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84DBB-0DFA-4D56-AEBC-3BBE10FB02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75880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5799" y="479144"/>
            <a:ext cx="11489115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5799" y="2395710"/>
            <a:ext cx="11489115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5799" y="8341240"/>
            <a:ext cx="299716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9A463A7-2D1A-4393-8F69-00E828BC2832}" type="datetimeFigureOut">
              <a:rPr lang="zh-CN" altLang="en-US" smtClean="0"/>
              <a:t>2024/9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412486" y="8341240"/>
            <a:ext cx="4495741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407754" y="8341240"/>
            <a:ext cx="299716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E84DBB-0DFA-4D56-AEBC-3BBE10FB02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5078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7957923-5FFF-2920-941D-42AB5DDC6710}"/>
              </a:ext>
            </a:extLst>
          </p:cNvPr>
          <p:cNvSpPr txBox="1"/>
          <p:nvPr/>
        </p:nvSpPr>
        <p:spPr>
          <a:xfrm>
            <a:off x="5246174" y="8293321"/>
            <a:ext cx="28283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GTEx v8 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zh-CN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tissue types</a:t>
            </a:r>
          </a:p>
        </p:txBody>
      </p:sp>
      <p:pic>
        <p:nvPicPr>
          <p:cNvPr id="3" name="图片 2" descr="图表, 树状图&#10;&#10;描述已自动生成">
            <a:extLst>
              <a:ext uri="{FF2B5EF4-FFF2-40B4-BE49-F238E27FC236}">
                <a16:creationId xmlns:a16="http://schemas.microsoft.com/office/drawing/2014/main" id="{5239B331-A04A-1357-7CE0-5B502C96809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548"/>
          <a:stretch/>
        </p:blipFill>
        <p:spPr>
          <a:xfrm>
            <a:off x="1154844" y="336885"/>
            <a:ext cx="4684198" cy="7447548"/>
          </a:xfrm>
          <a:prstGeom prst="rect">
            <a:avLst/>
          </a:prstGeom>
        </p:spPr>
      </p:pic>
      <p:pic>
        <p:nvPicPr>
          <p:cNvPr id="6" name="图片 5" descr="图片包含 日程表&#10;&#10;描述已自动生成">
            <a:extLst>
              <a:ext uri="{FF2B5EF4-FFF2-40B4-BE49-F238E27FC236}">
                <a16:creationId xmlns:a16="http://schemas.microsoft.com/office/drawing/2014/main" id="{9ABCED7D-E67D-745E-5622-65F52527DA4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878"/>
          <a:stretch/>
        </p:blipFill>
        <p:spPr>
          <a:xfrm>
            <a:off x="7350282" y="433137"/>
            <a:ext cx="4850255" cy="7203555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30D611D8-61EB-830A-DD03-A63D22051782}"/>
              </a:ext>
            </a:extLst>
          </p:cNvPr>
          <p:cNvSpPr txBox="1"/>
          <p:nvPr/>
        </p:nvSpPr>
        <p:spPr>
          <a:xfrm>
            <a:off x="1173386" y="7784433"/>
            <a:ext cx="509992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verage expression per label (log2 transformed)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883F479-88D5-5294-1A5A-5DED8582CBF5}"/>
              </a:ext>
            </a:extLst>
          </p:cNvPr>
          <p:cNvSpPr txBox="1"/>
          <p:nvPr/>
        </p:nvSpPr>
        <p:spPr>
          <a:xfrm>
            <a:off x="6291850" y="7795729"/>
            <a:ext cx="686517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verage of normalized expression per label (zero mean across samples)</a:t>
            </a:r>
          </a:p>
        </p:txBody>
      </p:sp>
    </p:spTree>
    <p:extLst>
      <p:ext uri="{BB962C8B-B14F-4D97-AF65-F5344CB8AC3E}">
        <p14:creationId xmlns:p14="http://schemas.microsoft.com/office/powerpoint/2010/main" val="15788438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7957923-5FFF-2920-941D-42AB5DDC6710}"/>
              </a:ext>
            </a:extLst>
          </p:cNvPr>
          <p:cNvSpPr txBox="1"/>
          <p:nvPr/>
        </p:nvSpPr>
        <p:spPr>
          <a:xfrm>
            <a:off x="5246174" y="7999256"/>
            <a:ext cx="28283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GTEx v8 54 tissue types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0D611D8-61EB-830A-DD03-A63D22051782}"/>
              </a:ext>
            </a:extLst>
          </p:cNvPr>
          <p:cNvSpPr txBox="1"/>
          <p:nvPr/>
        </p:nvSpPr>
        <p:spPr>
          <a:xfrm>
            <a:off x="855599" y="7319062"/>
            <a:ext cx="509992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verage expression per label (log2 transformed)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883F479-88D5-5294-1A5A-5DED8582CBF5}"/>
              </a:ext>
            </a:extLst>
          </p:cNvPr>
          <p:cNvSpPr txBox="1"/>
          <p:nvPr/>
        </p:nvSpPr>
        <p:spPr>
          <a:xfrm>
            <a:off x="6576120" y="7319062"/>
            <a:ext cx="751080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verage of normalized expression per label (zero mean across samples)</a:t>
            </a:r>
          </a:p>
        </p:txBody>
      </p:sp>
      <p:pic>
        <p:nvPicPr>
          <p:cNvPr id="17" name="图片 16" descr="图表, 树状图&#10;&#10;描述已自动生成">
            <a:extLst>
              <a:ext uri="{FF2B5EF4-FFF2-40B4-BE49-F238E27FC236}">
                <a16:creationId xmlns:a16="http://schemas.microsoft.com/office/drawing/2014/main" id="{CE7826AE-2B23-03EC-6D24-EBCA29588D6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593" y="353676"/>
            <a:ext cx="5759935" cy="6769017"/>
          </a:xfrm>
          <a:prstGeom prst="rect">
            <a:avLst/>
          </a:prstGeom>
        </p:spPr>
      </p:pic>
      <p:pic>
        <p:nvPicPr>
          <p:cNvPr id="19" name="图片 18" descr="图表&#10;&#10;描述已自动生成">
            <a:extLst>
              <a:ext uri="{FF2B5EF4-FFF2-40B4-BE49-F238E27FC236}">
                <a16:creationId xmlns:a16="http://schemas.microsoft.com/office/drawing/2014/main" id="{A37D4461-E08F-F3DA-7E12-4532C2F8F95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6742" y="353677"/>
            <a:ext cx="5759935" cy="67690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1694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</TotalTime>
  <Words>54</Words>
  <Application>Microsoft Office PowerPoint</Application>
  <PresentationFormat>自定义</PresentationFormat>
  <Paragraphs>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Eureka Li</dc:creator>
  <cp:lastModifiedBy>Eureka Li</cp:lastModifiedBy>
  <cp:revision>7</cp:revision>
  <dcterms:created xsi:type="dcterms:W3CDTF">2024-05-21T15:09:59Z</dcterms:created>
  <dcterms:modified xsi:type="dcterms:W3CDTF">2024-09-02T10:05:47Z</dcterms:modified>
</cp:coreProperties>
</file>